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121C83-D21A-124B-BC22-C7F74E36E9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C08CE1-9E8A-AB4E-8A22-373E1EE8B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3199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D6A1FE-1F75-4D40-A962-0382E2FEC68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5088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187CB5-AD4F-E9CB-9CCF-F2CB4085CA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C9D65E-A42C-ED04-E757-25DBD74CBD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8612E8-39EA-B1AF-033D-BD4D0B152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13CFCE-8F7F-05FA-C96A-305985AE6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09BD81-F145-A95F-94EC-8460732FB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323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468E96-35D6-10BC-C88F-ADEF721E5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BC3B44-DD3E-98D4-BF2E-3A1D29D0D7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0DCC5C-7F72-B498-B138-45F5A4255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790871-A346-B99B-766E-9C1C6176F3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1C8DB2-4180-04A3-0DB4-750ACB1D8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365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1015AE-912F-AAA8-65B7-785CE921C8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FF05D6-E1E2-9B20-4F51-83CAB99D65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BD66D3-87C4-69D9-D6AC-E0B64B580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05FD5-2A03-D172-62B1-1F22148E3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3FFFC6-EAB9-341B-5F6A-F6C5014DFE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051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631B38-FD2A-A230-1FA7-6F6EE6EE9D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45A054-8867-23D1-BE22-D4C051F146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4AE38A-6581-BEC0-0386-B4E023BB5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2D14B0-1E3A-A0E2-5BEE-3A51043DB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8A812E-FB69-1C84-6365-88FAA8174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415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4855C-9006-3D6B-F50C-05E38A2C1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4F4218-351B-6302-DD71-827FA67345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A2234D-E152-10D4-6AB8-3A0F06E32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CB46FF-5C2A-360F-1684-47D40FB07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C8E5B8-2624-43B2-DF7D-A0CFBB12F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210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550802-445E-AEDF-3927-63873CF651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B3E403-53FF-93E1-0D34-42C59D9385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97F3A5-AD67-EC78-FA92-50C9304C1E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9FD0EA-63A2-77DB-763C-31E547FD9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295D22-1F6B-C48C-8FFA-32070751C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EBD145-BF8A-4B1D-2B01-49D7B4BFA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492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AC571-13C6-3022-5520-874644951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F0EB8F-B46D-B5E4-CEBD-73073BDF76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81B627-7752-A090-2E2E-1ACC5A6874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3264EC-7A4C-4981-A788-30CBF7D5D8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A634C87-9CAB-66A2-9ABC-B610C3D192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5B0B572-55B9-2A8D-58DD-45A485C80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501C921-FC63-659E-6853-398E369C4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34C0BC2-C882-DB69-0F6E-04327CBAA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47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21DBD-CE43-8FFC-E754-FEEB2FAC19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D13743-1D2D-FC9A-42BC-9817D265F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90C256-B776-A14D-46B8-3D5AFBA1D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79E3929-7ECE-0FAB-8C72-568D62761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963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7FC168-B317-E80B-492A-D06254E5C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C516D3B-FA6E-E28D-902E-153F8594A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458407-4D25-8951-1CEB-B7CDC14E4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568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95A996-541A-0F8E-C15D-0E9ABEB79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41AB9B-3AF4-3681-50EC-6B3852DEBB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3B235E-1EC1-9CF4-45EC-719F43BD08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76148C-AED7-7EBF-41CA-714EA1BC7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277D37-4973-A72A-4F40-634F8F5C1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011330-62F2-F09A-2DA1-E491704A5D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755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816601-F1EB-F9BA-21E2-98555B4F9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95E0F1-6177-4D6A-5E25-288872C2DD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D3FDB2-953C-34F9-6264-6C4AE22891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CCA24C-0C79-1C94-AEA4-26BD3278A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3EEAEF-2999-FDCC-7B85-75DC6EAD5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867C10-38A3-BA4F-0E70-61B83828F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869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C2CD9E-1C67-55E4-C553-6C9BBA045B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F44C99-DF20-8153-3FC0-D55FC05FD9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A544B9-8996-72BE-3A41-A0B26C41B2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8D8F6-02FB-9B49-B485-7C0CEE93FDD3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1E3FA6-0127-5891-71C6-8B9A888E92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D59154-06B9-F929-8205-200D351AD5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48DC2-9579-B845-A805-5FCCA41E04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050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9913BEDD-30B1-7C53-6C58-4FCE0F1F9178}"/>
              </a:ext>
            </a:extLst>
          </p:cNvPr>
          <p:cNvGrpSpPr/>
          <p:nvPr/>
        </p:nvGrpSpPr>
        <p:grpSpPr>
          <a:xfrm>
            <a:off x="1795018" y="3697317"/>
            <a:ext cx="8371329" cy="342714"/>
            <a:chOff x="1814401" y="6138429"/>
            <a:chExt cx="8371329" cy="342714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243FE28-27F8-3AB4-2FFA-8E0BFA1B124F}"/>
                </a:ext>
              </a:extLst>
            </p:cNvPr>
            <p:cNvSpPr txBox="1"/>
            <p:nvPr/>
          </p:nvSpPr>
          <p:spPr>
            <a:xfrm>
              <a:off x="1814401" y="6138429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4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EE8FFB6-C0CD-6C3E-1607-309C03857097}"/>
                </a:ext>
              </a:extLst>
            </p:cNvPr>
            <p:cNvSpPr txBox="1"/>
            <p:nvPr/>
          </p:nvSpPr>
          <p:spPr>
            <a:xfrm>
              <a:off x="5321677" y="6173366"/>
              <a:ext cx="7088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/H4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654D81F-B43E-8460-F937-85257C94D444}"/>
                </a:ext>
              </a:extLst>
            </p:cNvPr>
            <p:cNvSpPr txBox="1"/>
            <p:nvPr/>
          </p:nvSpPr>
          <p:spPr>
            <a:xfrm>
              <a:off x="9055677" y="6156765"/>
              <a:ext cx="11300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MacroH2A1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993F8EBA-61DC-5696-9FC2-BE6F6FEFF64F}"/>
              </a:ext>
            </a:extLst>
          </p:cNvPr>
          <p:cNvSpPr txBox="1"/>
          <p:nvPr/>
        </p:nvSpPr>
        <p:spPr>
          <a:xfrm>
            <a:off x="4077720" y="51720"/>
            <a:ext cx="2778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/>
              <a:t>Histones </a:t>
            </a:r>
            <a:r>
              <a:rPr lang="en-IN" b="1" dirty="0"/>
              <a:t>vs Smoking Status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A3A5B281-35AB-F00A-1508-232354351EA3}"/>
              </a:ext>
            </a:extLst>
          </p:cNvPr>
          <p:cNvGrpSpPr/>
          <p:nvPr/>
        </p:nvGrpSpPr>
        <p:grpSpPr>
          <a:xfrm>
            <a:off x="1653427" y="744962"/>
            <a:ext cx="8258025" cy="368097"/>
            <a:chOff x="1485261" y="744962"/>
            <a:chExt cx="8258025" cy="368097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F7B290D-267F-E7D9-DBEC-1EDB44210452}"/>
                </a:ext>
              </a:extLst>
            </p:cNvPr>
            <p:cNvSpPr txBox="1"/>
            <p:nvPr/>
          </p:nvSpPr>
          <p:spPr>
            <a:xfrm>
              <a:off x="1485261" y="805282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2D249C6-F1C0-2910-E9FD-24D605FD497F}"/>
                </a:ext>
              </a:extLst>
            </p:cNvPr>
            <p:cNvSpPr txBox="1"/>
            <p:nvPr/>
          </p:nvSpPr>
          <p:spPr>
            <a:xfrm>
              <a:off x="5200297" y="744962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B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3167FA8-143E-A0A0-2FAA-3C6DF7BB9CA4}"/>
                </a:ext>
              </a:extLst>
            </p:cNvPr>
            <p:cNvSpPr txBox="1"/>
            <p:nvPr/>
          </p:nvSpPr>
          <p:spPr>
            <a:xfrm>
              <a:off x="9330994" y="756578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231972ED-3F98-B09F-48E1-F41A2416DCF4}"/>
              </a:ext>
            </a:extLst>
          </p:cNvPr>
          <p:cNvSpPr txBox="1"/>
          <p:nvPr/>
        </p:nvSpPr>
        <p:spPr>
          <a:xfrm rot="16200000">
            <a:off x="125101" y="2180628"/>
            <a:ext cx="394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A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F731982-A0C0-11C8-FB8A-9A8BE078C25E}"/>
              </a:ext>
            </a:extLst>
          </p:cNvPr>
          <p:cNvSpPr/>
          <p:nvPr/>
        </p:nvSpPr>
        <p:spPr>
          <a:xfrm>
            <a:off x="2891215" y="664769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F0FC3E5-0070-6AC9-4766-CCDD7E42929C}"/>
              </a:ext>
            </a:extLst>
          </p:cNvPr>
          <p:cNvSpPr/>
          <p:nvPr/>
        </p:nvSpPr>
        <p:spPr>
          <a:xfrm>
            <a:off x="2893713" y="836019"/>
            <a:ext cx="131348" cy="50824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E69C2F1-3684-672D-5197-A48725A0D831}"/>
              </a:ext>
            </a:extLst>
          </p:cNvPr>
          <p:cNvSpPr/>
          <p:nvPr/>
        </p:nvSpPr>
        <p:spPr>
          <a:xfrm>
            <a:off x="2891215" y="1007269"/>
            <a:ext cx="131348" cy="50824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A735124-2E6E-B735-66B3-A4D5F5D863E7}"/>
              </a:ext>
            </a:extLst>
          </p:cNvPr>
          <p:cNvSpPr txBox="1"/>
          <p:nvPr/>
        </p:nvSpPr>
        <p:spPr>
          <a:xfrm>
            <a:off x="2981936" y="570916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urren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064FDE1-B8EA-A545-7927-A18AD7A3E7CA}"/>
              </a:ext>
            </a:extLst>
          </p:cNvPr>
          <p:cNvSpPr txBox="1"/>
          <p:nvPr/>
        </p:nvSpPr>
        <p:spPr>
          <a:xfrm>
            <a:off x="2981936" y="768970"/>
            <a:ext cx="6832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Ex-Smok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2788F97-8E64-2F2A-6D46-A7524476A677}"/>
              </a:ext>
            </a:extLst>
          </p:cNvPr>
          <p:cNvSpPr txBox="1"/>
          <p:nvPr/>
        </p:nvSpPr>
        <p:spPr>
          <a:xfrm>
            <a:off x="2982808" y="928925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eve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A7EFE08-C499-2AAD-FC1E-56EEBDEB3566}"/>
              </a:ext>
            </a:extLst>
          </p:cNvPr>
          <p:cNvSpPr txBox="1"/>
          <p:nvPr/>
        </p:nvSpPr>
        <p:spPr>
          <a:xfrm>
            <a:off x="897153" y="313215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F15FD6B-D54F-D9B4-1457-449FAAFF138B}"/>
              </a:ext>
            </a:extLst>
          </p:cNvPr>
          <p:cNvSpPr txBox="1"/>
          <p:nvPr/>
        </p:nvSpPr>
        <p:spPr>
          <a:xfrm>
            <a:off x="1645017" y="3132158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C7C0C28-D4DD-E739-59AB-CBB85E49BAE0}"/>
              </a:ext>
            </a:extLst>
          </p:cNvPr>
          <p:cNvSpPr txBox="1"/>
          <p:nvPr/>
        </p:nvSpPr>
        <p:spPr>
          <a:xfrm>
            <a:off x="2427344" y="3121756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pic>
        <p:nvPicPr>
          <p:cNvPr id="25" name="Content Placeholder 5">
            <a:extLst>
              <a:ext uri="{FF2B5EF4-FFF2-40B4-BE49-F238E27FC236}">
                <a16:creationId xmlns:a16="http://schemas.microsoft.com/office/drawing/2014/main" id="{DCC6C30B-0AFF-C056-5410-78B30DBF4BF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0" r="13040" b="6068"/>
          <a:stretch/>
        </p:blipFill>
        <p:spPr>
          <a:xfrm>
            <a:off x="454267" y="1174992"/>
            <a:ext cx="3065173" cy="1981209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FC5145A0-642E-67D5-372C-9C1733DB88D4}"/>
              </a:ext>
            </a:extLst>
          </p:cNvPr>
          <p:cNvSpPr txBox="1"/>
          <p:nvPr/>
        </p:nvSpPr>
        <p:spPr>
          <a:xfrm rot="16200000">
            <a:off x="3792675" y="2162643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B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EF30A7B-EFDB-46C1-CB60-2561E790891E}"/>
              </a:ext>
            </a:extLst>
          </p:cNvPr>
          <p:cNvSpPr/>
          <p:nvPr/>
        </p:nvSpPr>
        <p:spPr>
          <a:xfrm>
            <a:off x="6559590" y="646784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919DDE0-B662-ACC1-895A-94FAA3F63526}"/>
              </a:ext>
            </a:extLst>
          </p:cNvPr>
          <p:cNvSpPr/>
          <p:nvPr/>
        </p:nvSpPr>
        <p:spPr>
          <a:xfrm>
            <a:off x="6562088" y="818034"/>
            <a:ext cx="131348" cy="50824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EF11CB23-8BBB-0ECE-78F6-66B30E32EF23}"/>
              </a:ext>
            </a:extLst>
          </p:cNvPr>
          <p:cNvSpPr/>
          <p:nvPr/>
        </p:nvSpPr>
        <p:spPr>
          <a:xfrm>
            <a:off x="6559590" y="989284"/>
            <a:ext cx="131348" cy="50824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94A5620-FCA8-9FA0-4F43-F36CF9087D3F}"/>
              </a:ext>
            </a:extLst>
          </p:cNvPr>
          <p:cNvSpPr txBox="1"/>
          <p:nvPr/>
        </p:nvSpPr>
        <p:spPr>
          <a:xfrm>
            <a:off x="6650311" y="552931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urren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B1FC325-5BA0-BCF7-8AEC-F6107BC0BB53}"/>
              </a:ext>
            </a:extLst>
          </p:cNvPr>
          <p:cNvSpPr txBox="1"/>
          <p:nvPr/>
        </p:nvSpPr>
        <p:spPr>
          <a:xfrm>
            <a:off x="6650311" y="750985"/>
            <a:ext cx="6832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Ex-Smoker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9CA7D67-9C18-4ABF-F4E5-275CAB92C199}"/>
              </a:ext>
            </a:extLst>
          </p:cNvPr>
          <p:cNvSpPr txBox="1"/>
          <p:nvPr/>
        </p:nvSpPr>
        <p:spPr>
          <a:xfrm>
            <a:off x="6651183" y="910940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ever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645CB44-F448-F118-960B-D4BC4C53DF34}"/>
              </a:ext>
            </a:extLst>
          </p:cNvPr>
          <p:cNvSpPr txBox="1"/>
          <p:nvPr/>
        </p:nvSpPr>
        <p:spPr>
          <a:xfrm>
            <a:off x="4565528" y="3114173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F8837DA-5F8B-8C40-4E58-FD7D55E3DFE1}"/>
              </a:ext>
            </a:extLst>
          </p:cNvPr>
          <p:cNvSpPr txBox="1"/>
          <p:nvPr/>
        </p:nvSpPr>
        <p:spPr>
          <a:xfrm>
            <a:off x="5313392" y="3114173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C2C38DD-8033-6273-E378-796674039C39}"/>
              </a:ext>
            </a:extLst>
          </p:cNvPr>
          <p:cNvSpPr txBox="1"/>
          <p:nvPr/>
        </p:nvSpPr>
        <p:spPr>
          <a:xfrm>
            <a:off x="6095719" y="3103771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0602CA7D-6CD5-51C5-36AA-EF4D0FB69AC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0" r="15904" b="6301"/>
          <a:stretch/>
        </p:blipFill>
        <p:spPr>
          <a:xfrm>
            <a:off x="4163355" y="1202068"/>
            <a:ext cx="3079259" cy="1903059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E2709FA3-20F2-3D3E-C814-68F24DEF3514}"/>
              </a:ext>
            </a:extLst>
          </p:cNvPr>
          <p:cNvSpPr txBox="1"/>
          <p:nvPr/>
        </p:nvSpPr>
        <p:spPr>
          <a:xfrm rot="16200000">
            <a:off x="7852140" y="2168236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566DD2F9-6297-1ECE-9D5D-24FD4097BF20}"/>
              </a:ext>
            </a:extLst>
          </p:cNvPr>
          <p:cNvSpPr/>
          <p:nvPr/>
        </p:nvSpPr>
        <p:spPr>
          <a:xfrm>
            <a:off x="10584591" y="652377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7C1D1375-C25B-AA59-ACDA-25A752802A01}"/>
              </a:ext>
            </a:extLst>
          </p:cNvPr>
          <p:cNvSpPr/>
          <p:nvPr/>
        </p:nvSpPr>
        <p:spPr>
          <a:xfrm>
            <a:off x="10587089" y="823627"/>
            <a:ext cx="131348" cy="50824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42CD30C3-506B-28D2-0883-F800028BE378}"/>
              </a:ext>
            </a:extLst>
          </p:cNvPr>
          <p:cNvSpPr/>
          <p:nvPr/>
        </p:nvSpPr>
        <p:spPr>
          <a:xfrm>
            <a:off x="10584591" y="994877"/>
            <a:ext cx="131348" cy="50824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C8026F0-1B53-4FBF-F41D-0473C5E2FD24}"/>
              </a:ext>
            </a:extLst>
          </p:cNvPr>
          <p:cNvSpPr txBox="1"/>
          <p:nvPr/>
        </p:nvSpPr>
        <p:spPr>
          <a:xfrm>
            <a:off x="10675312" y="558524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urren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CD53194-FE0B-8D9B-D51F-57C817518C18}"/>
              </a:ext>
            </a:extLst>
          </p:cNvPr>
          <p:cNvSpPr txBox="1"/>
          <p:nvPr/>
        </p:nvSpPr>
        <p:spPr>
          <a:xfrm>
            <a:off x="10675312" y="756578"/>
            <a:ext cx="6832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Ex-Smoker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364DC87-8929-C3F5-FDE8-7C9A85DE3A5B}"/>
              </a:ext>
            </a:extLst>
          </p:cNvPr>
          <p:cNvSpPr txBox="1"/>
          <p:nvPr/>
        </p:nvSpPr>
        <p:spPr>
          <a:xfrm>
            <a:off x="10676184" y="916533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ever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0C54AA4-C539-C136-9324-FD825649FC23}"/>
              </a:ext>
            </a:extLst>
          </p:cNvPr>
          <p:cNvSpPr txBox="1"/>
          <p:nvPr/>
        </p:nvSpPr>
        <p:spPr>
          <a:xfrm>
            <a:off x="8590529" y="311976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BCCF3F8-E63B-ADBB-0282-79DDB1C6406D}"/>
              </a:ext>
            </a:extLst>
          </p:cNvPr>
          <p:cNvSpPr txBox="1"/>
          <p:nvPr/>
        </p:nvSpPr>
        <p:spPr>
          <a:xfrm>
            <a:off x="9338393" y="3119766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171DAC8-E65C-EE2A-13AC-037300B3EB66}"/>
              </a:ext>
            </a:extLst>
          </p:cNvPr>
          <p:cNvSpPr txBox="1"/>
          <p:nvPr/>
        </p:nvSpPr>
        <p:spPr>
          <a:xfrm>
            <a:off x="10120720" y="3109364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pic>
        <p:nvPicPr>
          <p:cNvPr id="53" name="Content Placeholder 6">
            <a:extLst>
              <a:ext uri="{FF2B5EF4-FFF2-40B4-BE49-F238E27FC236}">
                <a16:creationId xmlns:a16="http://schemas.microsoft.com/office/drawing/2014/main" id="{BC1799A1-E78D-6BD5-D429-337330FC202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8" r="15082" b="6301"/>
          <a:stretch/>
        </p:blipFill>
        <p:spPr>
          <a:xfrm>
            <a:off x="8050634" y="1198150"/>
            <a:ext cx="3123689" cy="1903059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41D7DE31-76F4-DC8A-169E-A766E2A8B3D1}"/>
              </a:ext>
            </a:extLst>
          </p:cNvPr>
          <p:cNvSpPr txBox="1"/>
          <p:nvPr/>
        </p:nvSpPr>
        <p:spPr>
          <a:xfrm rot="16200000">
            <a:off x="249975" y="5113457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4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B361AB1B-E904-4513-9F23-A1A04D98F283}"/>
              </a:ext>
            </a:extLst>
          </p:cNvPr>
          <p:cNvSpPr/>
          <p:nvPr/>
        </p:nvSpPr>
        <p:spPr>
          <a:xfrm>
            <a:off x="2982426" y="3597598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14DBB400-A341-D8F4-5E3D-B1F5BEBD1538}"/>
              </a:ext>
            </a:extLst>
          </p:cNvPr>
          <p:cNvSpPr/>
          <p:nvPr/>
        </p:nvSpPr>
        <p:spPr>
          <a:xfrm>
            <a:off x="2984924" y="3768848"/>
            <a:ext cx="131348" cy="50824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C394BED0-98AE-F1DE-D244-70C9537F006D}"/>
              </a:ext>
            </a:extLst>
          </p:cNvPr>
          <p:cNvSpPr/>
          <p:nvPr/>
        </p:nvSpPr>
        <p:spPr>
          <a:xfrm>
            <a:off x="2982426" y="3940098"/>
            <a:ext cx="131348" cy="50824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6140C5A-9A5C-BCF2-92B7-506F692B9E3E}"/>
              </a:ext>
            </a:extLst>
          </p:cNvPr>
          <p:cNvSpPr txBox="1"/>
          <p:nvPr/>
        </p:nvSpPr>
        <p:spPr>
          <a:xfrm>
            <a:off x="3073147" y="3503745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urrent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24BA89C-D7C7-D4B4-C651-4795921C6DE0}"/>
              </a:ext>
            </a:extLst>
          </p:cNvPr>
          <p:cNvSpPr txBox="1"/>
          <p:nvPr/>
        </p:nvSpPr>
        <p:spPr>
          <a:xfrm>
            <a:off x="3073147" y="3701799"/>
            <a:ext cx="6832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Ex-Smoker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7B1C7CB-D684-C1DE-552A-23A1C0583718}"/>
              </a:ext>
            </a:extLst>
          </p:cNvPr>
          <p:cNvSpPr txBox="1"/>
          <p:nvPr/>
        </p:nvSpPr>
        <p:spPr>
          <a:xfrm>
            <a:off x="3074019" y="3861754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ever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8EEDCF6-35D8-96F9-4FAD-76D3AE1A0622}"/>
              </a:ext>
            </a:extLst>
          </p:cNvPr>
          <p:cNvSpPr txBox="1"/>
          <p:nvPr/>
        </p:nvSpPr>
        <p:spPr>
          <a:xfrm>
            <a:off x="1016218" y="6216144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A3D8CF9-28B9-1611-A425-5147F0C6CB01}"/>
              </a:ext>
            </a:extLst>
          </p:cNvPr>
          <p:cNvSpPr txBox="1"/>
          <p:nvPr/>
        </p:nvSpPr>
        <p:spPr>
          <a:xfrm>
            <a:off x="1764082" y="6216144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1DFA42B-7B7F-906A-59AA-04626E326489}"/>
              </a:ext>
            </a:extLst>
          </p:cNvPr>
          <p:cNvSpPr txBox="1"/>
          <p:nvPr/>
        </p:nvSpPr>
        <p:spPr>
          <a:xfrm>
            <a:off x="2546409" y="6205742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pic>
        <p:nvPicPr>
          <p:cNvPr id="65" name="Content Placeholder 6">
            <a:extLst>
              <a:ext uri="{FF2B5EF4-FFF2-40B4-BE49-F238E27FC236}">
                <a16:creationId xmlns:a16="http://schemas.microsoft.com/office/drawing/2014/main" id="{9D5B0017-8059-4AD6-BD9E-61639963D00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3" r="13783" b="6116"/>
          <a:stretch/>
        </p:blipFill>
        <p:spPr>
          <a:xfrm>
            <a:off x="540428" y="4132271"/>
            <a:ext cx="3016156" cy="2096207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2106FC70-167E-B8FE-17CD-C8088044403E}"/>
              </a:ext>
            </a:extLst>
          </p:cNvPr>
          <p:cNvSpPr txBox="1"/>
          <p:nvPr/>
        </p:nvSpPr>
        <p:spPr>
          <a:xfrm rot="16200000">
            <a:off x="3717365" y="5113456"/>
            <a:ext cx="5084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/H4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E74194C4-30D1-6750-26F7-39EA34D25F9F}"/>
              </a:ext>
            </a:extLst>
          </p:cNvPr>
          <p:cNvSpPr/>
          <p:nvPr/>
        </p:nvSpPr>
        <p:spPr>
          <a:xfrm>
            <a:off x="6474372" y="3615047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1294E603-688D-9487-5E9F-EB75551091FC}"/>
              </a:ext>
            </a:extLst>
          </p:cNvPr>
          <p:cNvSpPr/>
          <p:nvPr/>
        </p:nvSpPr>
        <p:spPr>
          <a:xfrm>
            <a:off x="6476870" y="3786297"/>
            <a:ext cx="131348" cy="50824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E98C719A-25CA-A9D5-EEDD-B987AC7DEE31}"/>
              </a:ext>
            </a:extLst>
          </p:cNvPr>
          <p:cNvSpPr/>
          <p:nvPr/>
        </p:nvSpPr>
        <p:spPr>
          <a:xfrm>
            <a:off x="6474372" y="3957547"/>
            <a:ext cx="131348" cy="50824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DB696F8-621E-089F-0A59-0B3D4D25E32F}"/>
              </a:ext>
            </a:extLst>
          </p:cNvPr>
          <p:cNvSpPr txBox="1"/>
          <p:nvPr/>
        </p:nvSpPr>
        <p:spPr>
          <a:xfrm>
            <a:off x="6565093" y="3521194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urrent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2ADD8FA-B524-645B-ED3D-99B668A8C701}"/>
              </a:ext>
            </a:extLst>
          </p:cNvPr>
          <p:cNvSpPr txBox="1"/>
          <p:nvPr/>
        </p:nvSpPr>
        <p:spPr>
          <a:xfrm>
            <a:off x="6565093" y="3719248"/>
            <a:ext cx="6832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Ex-Smoker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EA31C7F-6D5C-0D79-74B3-F426B10E5A11}"/>
              </a:ext>
            </a:extLst>
          </p:cNvPr>
          <p:cNvSpPr txBox="1"/>
          <p:nvPr/>
        </p:nvSpPr>
        <p:spPr>
          <a:xfrm>
            <a:off x="6565965" y="3879203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ever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9790070-F555-8881-1A8D-6A6772AFF41C}"/>
              </a:ext>
            </a:extLst>
          </p:cNvPr>
          <p:cNvSpPr txBox="1"/>
          <p:nvPr/>
        </p:nvSpPr>
        <p:spPr>
          <a:xfrm>
            <a:off x="4508164" y="6233593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4BEF857-E75C-C50C-89C1-54CF6CEBE419}"/>
              </a:ext>
            </a:extLst>
          </p:cNvPr>
          <p:cNvSpPr txBox="1"/>
          <p:nvPr/>
        </p:nvSpPr>
        <p:spPr>
          <a:xfrm>
            <a:off x="5256028" y="6233593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5319C7C-0CE2-7D2A-EF61-B726F87D960D}"/>
              </a:ext>
            </a:extLst>
          </p:cNvPr>
          <p:cNvSpPr txBox="1"/>
          <p:nvPr/>
        </p:nvSpPr>
        <p:spPr>
          <a:xfrm>
            <a:off x="6038355" y="6223191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pic>
        <p:nvPicPr>
          <p:cNvPr id="77" name="Content Placeholder 6">
            <a:extLst>
              <a:ext uri="{FF2B5EF4-FFF2-40B4-BE49-F238E27FC236}">
                <a16:creationId xmlns:a16="http://schemas.microsoft.com/office/drawing/2014/main" id="{C4727A56-F1BC-7F53-9EBB-3C2FA2CB169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2" r="14233" b="5138"/>
          <a:stretch/>
        </p:blipFill>
        <p:spPr>
          <a:xfrm>
            <a:off x="4113040" y="4115551"/>
            <a:ext cx="3079259" cy="2118042"/>
          </a:xfrm>
          <a:prstGeom prst="rect">
            <a:avLst/>
          </a:prstGeom>
        </p:spPr>
      </p:pic>
      <p:sp>
        <p:nvSpPr>
          <p:cNvPr id="78" name="Rectangle 77">
            <a:extLst>
              <a:ext uri="{FF2B5EF4-FFF2-40B4-BE49-F238E27FC236}">
                <a16:creationId xmlns:a16="http://schemas.microsoft.com/office/drawing/2014/main" id="{E473F6FB-9954-6311-6C96-DAD18D010819}"/>
              </a:ext>
            </a:extLst>
          </p:cNvPr>
          <p:cNvSpPr/>
          <p:nvPr/>
        </p:nvSpPr>
        <p:spPr>
          <a:xfrm>
            <a:off x="10426080" y="3680930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30AEFBC4-8B9A-19AF-6ACE-F4BA19BDD041}"/>
              </a:ext>
            </a:extLst>
          </p:cNvPr>
          <p:cNvSpPr/>
          <p:nvPr/>
        </p:nvSpPr>
        <p:spPr>
          <a:xfrm>
            <a:off x="10428578" y="3852180"/>
            <a:ext cx="131348" cy="50824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FFAF11DC-1789-F5B2-F5AA-CC53735F9169}"/>
              </a:ext>
            </a:extLst>
          </p:cNvPr>
          <p:cNvSpPr/>
          <p:nvPr/>
        </p:nvSpPr>
        <p:spPr>
          <a:xfrm>
            <a:off x="10426080" y="4023430"/>
            <a:ext cx="131348" cy="50824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DEF1247-EDCF-A2BE-2AD8-C2F35F98DC27}"/>
              </a:ext>
            </a:extLst>
          </p:cNvPr>
          <p:cNvSpPr txBox="1"/>
          <p:nvPr/>
        </p:nvSpPr>
        <p:spPr>
          <a:xfrm>
            <a:off x="10516801" y="3587077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urrent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0A592F6-8550-9704-959C-331FC317A7B9}"/>
              </a:ext>
            </a:extLst>
          </p:cNvPr>
          <p:cNvSpPr txBox="1"/>
          <p:nvPr/>
        </p:nvSpPr>
        <p:spPr>
          <a:xfrm>
            <a:off x="10516801" y="3785131"/>
            <a:ext cx="6832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Ex-Smoker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2436E4B4-21B6-9EF8-9149-A49390A5D079}"/>
              </a:ext>
            </a:extLst>
          </p:cNvPr>
          <p:cNvSpPr txBox="1"/>
          <p:nvPr/>
        </p:nvSpPr>
        <p:spPr>
          <a:xfrm>
            <a:off x="10517673" y="3945086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ever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090750F-8185-D7C4-3D66-DE078673136F}"/>
              </a:ext>
            </a:extLst>
          </p:cNvPr>
          <p:cNvSpPr txBox="1"/>
          <p:nvPr/>
        </p:nvSpPr>
        <p:spPr>
          <a:xfrm>
            <a:off x="8459872" y="629947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BD5070F-7368-025F-9108-909176D99DD4}"/>
              </a:ext>
            </a:extLst>
          </p:cNvPr>
          <p:cNvSpPr txBox="1"/>
          <p:nvPr/>
        </p:nvSpPr>
        <p:spPr>
          <a:xfrm>
            <a:off x="9207736" y="6299476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844C1D57-2C6E-FF97-94F9-3EAF2FED9AD4}"/>
              </a:ext>
            </a:extLst>
          </p:cNvPr>
          <p:cNvSpPr txBox="1"/>
          <p:nvPr/>
        </p:nvSpPr>
        <p:spPr>
          <a:xfrm>
            <a:off x="9990063" y="6289074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AF357A1-1116-8CEF-3EB0-08B8A9A3C8AB}"/>
              </a:ext>
            </a:extLst>
          </p:cNvPr>
          <p:cNvSpPr txBox="1"/>
          <p:nvPr/>
        </p:nvSpPr>
        <p:spPr>
          <a:xfrm rot="16200000">
            <a:off x="7514709" y="5125039"/>
            <a:ext cx="7713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croH2A1</a:t>
            </a:r>
          </a:p>
        </p:txBody>
      </p:sp>
      <p:pic>
        <p:nvPicPr>
          <p:cNvPr id="89" name="Content Placeholder 6">
            <a:extLst>
              <a:ext uri="{FF2B5EF4-FFF2-40B4-BE49-F238E27FC236}">
                <a16:creationId xmlns:a16="http://schemas.microsoft.com/office/drawing/2014/main" id="{0E5EAD74-73C2-1D8B-E2AB-F17202DDE3A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6" r="11970" b="6116"/>
          <a:stretch/>
        </p:blipFill>
        <p:spPr>
          <a:xfrm>
            <a:off x="8015807" y="4154570"/>
            <a:ext cx="3244439" cy="2096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5846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Macintosh PowerPoint</Application>
  <PresentationFormat>Widescreen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lio Vinciguera</dc:creator>
  <cp:lastModifiedBy>Manlio Vinciguera</cp:lastModifiedBy>
  <cp:revision>1</cp:revision>
  <dcterms:created xsi:type="dcterms:W3CDTF">2025-11-02T17:45:31Z</dcterms:created>
  <dcterms:modified xsi:type="dcterms:W3CDTF">2025-11-02T17:45:48Z</dcterms:modified>
</cp:coreProperties>
</file>